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  <p:sldId id="26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633"/>
  </p:normalViewPr>
  <p:slideViewPr>
    <p:cSldViewPr snapToGrid="0" snapToObjects="1">
      <p:cViewPr varScale="1">
        <p:scale>
          <a:sx n="93" d="100"/>
          <a:sy n="93" d="100"/>
        </p:scale>
        <p:origin x="3408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358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809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548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231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675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470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818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773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948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616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574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65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ABBA19A-957F-9049-B113-B60AF44D0D7C}"/>
              </a:ext>
            </a:extLst>
          </p:cNvPr>
          <p:cNvSpPr txBox="1"/>
          <p:nvPr/>
        </p:nvSpPr>
        <p:spPr>
          <a:xfrm>
            <a:off x="0" y="0"/>
            <a:ext cx="16349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table 1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C9306E6-6797-A949-9B06-36D9F3FC4A6A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48143" y="276999"/>
          <a:ext cx="5403275" cy="944281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58405">
                  <a:extLst>
                    <a:ext uri="{9D8B030D-6E8A-4147-A177-3AD203B41FA5}">
                      <a16:colId xmlns:a16="http://schemas.microsoft.com/office/drawing/2014/main" val="2314897029"/>
                    </a:ext>
                  </a:extLst>
                </a:gridCol>
                <a:gridCol w="1655201">
                  <a:extLst>
                    <a:ext uri="{9D8B030D-6E8A-4147-A177-3AD203B41FA5}">
                      <a16:colId xmlns:a16="http://schemas.microsoft.com/office/drawing/2014/main" val="4069463937"/>
                    </a:ext>
                  </a:extLst>
                </a:gridCol>
                <a:gridCol w="1060074">
                  <a:extLst>
                    <a:ext uri="{9D8B030D-6E8A-4147-A177-3AD203B41FA5}">
                      <a16:colId xmlns:a16="http://schemas.microsoft.com/office/drawing/2014/main" val="95012923"/>
                    </a:ext>
                  </a:extLst>
                </a:gridCol>
                <a:gridCol w="1729595">
                  <a:extLst>
                    <a:ext uri="{9D8B030D-6E8A-4147-A177-3AD203B41FA5}">
                      <a16:colId xmlns:a16="http://schemas.microsoft.com/office/drawing/2014/main" val="2127483000"/>
                    </a:ext>
                  </a:extLst>
                </a:gridCol>
              </a:tblGrid>
              <a:tr h="363185">
                <a:tc>
                  <a:txBody>
                    <a:bodyPr/>
                    <a:lstStyle/>
                    <a:p>
                      <a:r>
                        <a:rPr lang="en-US" sz="1200" b="1" dirty="0"/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Assay numb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Gene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Assay numb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566441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US" sz="1200" dirty="0"/>
                        <a:t>GA</a:t>
                      </a:r>
                      <a:r>
                        <a:rPr lang="en-US" sz="1200" i="1" dirty="0"/>
                        <a:t>PD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99999905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INH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1410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586237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PRT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99999909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INHB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0103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942389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GUSB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99999908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INHBB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3582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229034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ACVR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53836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INHBC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3745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7607089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ACVR1B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923299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LTBP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386448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072708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ACVR2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55658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LTBP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66367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874856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ACVR2B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60960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LTBP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21445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8828766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HBS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962908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AD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95432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414073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NFATC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542675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AD2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83425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189145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RHO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357608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PPP2CA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427259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705192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18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999999901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PPP2CB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357739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997441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MP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5419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APK1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7066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7912667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MP3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609638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APK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385075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626051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MP4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370078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RBL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765707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3396822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MP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4930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RBL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80562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2082715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MP6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3470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RAF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4119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778719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MP7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3476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KNK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374375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013440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FMOD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57619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APK8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548508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27169549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FNT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357739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DUSP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610256_g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8631569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GDF2</a:t>
                      </a:r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1191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P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93689_s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0097370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STN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9336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AP3K7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7373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41286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GDF9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93364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FDP1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955491_g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885097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GDF10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9203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GFA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(Hs00608187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83380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IFN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414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GFΒ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999999918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3030596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US" sz="1200" i="1" dirty="0"/>
                        <a:t>IL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4131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GFΒ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4244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96479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373291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BAFB5C5-548E-4741-9465-ADBC56DDB23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48579" y="517099"/>
          <a:ext cx="5347421" cy="8716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28851">
                  <a:extLst>
                    <a:ext uri="{9D8B030D-6E8A-4147-A177-3AD203B41FA5}">
                      <a16:colId xmlns:a16="http://schemas.microsoft.com/office/drawing/2014/main" val="952885856"/>
                    </a:ext>
                  </a:extLst>
                </a:gridCol>
                <a:gridCol w="1708871">
                  <a:extLst>
                    <a:ext uri="{9D8B030D-6E8A-4147-A177-3AD203B41FA5}">
                      <a16:colId xmlns:a16="http://schemas.microsoft.com/office/drawing/2014/main" val="850890071"/>
                    </a:ext>
                  </a:extLst>
                </a:gridCol>
                <a:gridCol w="998441">
                  <a:extLst>
                    <a:ext uri="{9D8B030D-6E8A-4147-A177-3AD203B41FA5}">
                      <a16:colId xmlns:a16="http://schemas.microsoft.com/office/drawing/2014/main" val="1179232007"/>
                    </a:ext>
                  </a:extLst>
                </a:gridCol>
                <a:gridCol w="1411258">
                  <a:extLst>
                    <a:ext uri="{9D8B030D-6E8A-4147-A177-3AD203B41FA5}">
                      <a16:colId xmlns:a16="http://schemas.microsoft.com/office/drawing/2014/main" val="2150832595"/>
                    </a:ext>
                  </a:extLst>
                </a:gridCol>
              </a:tblGrid>
              <a:tr h="363185">
                <a:tc>
                  <a:txBody>
                    <a:bodyPr/>
                    <a:lstStyle/>
                    <a:p>
                      <a:r>
                        <a:rPr lang="en-US" sz="1200" b="1" dirty="0"/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Assay numb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Assay numb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8398806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GFΒ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4245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AD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2222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8319787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RA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978050_g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AD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2068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041614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HR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415315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AD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95437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249153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MP1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93764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AD6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8579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219364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NOG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7135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AD7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8696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512554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APK1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15115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AD9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95441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930406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GFΒRAP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88614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NODAL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415443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81001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ROCK2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8154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LFTY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745761_s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148495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RAF6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939742_g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GFΒR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610319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2106938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NRAS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80035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GFΒR2</a:t>
                      </a:r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559661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52780397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RBX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360274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GFΒR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4257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189764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URF1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410929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NF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4128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575332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MURF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(Hs0022420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GDF5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67060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3494142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INHBE</a:t>
                      </a:r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368884_g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LTBP4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86025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1326277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IL1B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1555410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RE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982555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0188789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AC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4179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AS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67157_s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529773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ACE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108533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AGTR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58938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754577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AGT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158621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AGTR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2621316_s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896102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MPR1B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1010965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DKRB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664201_s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9867986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MPR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76148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OL1A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64004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0323427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REBBP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173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OL1A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1028956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005878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DC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754870_s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NR2C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991824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343498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AB1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19614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EP300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00230938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343430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305DFCE-7CB1-B847-A1F1-8C0CFE4540E9}"/>
              </a:ext>
            </a:extLst>
          </p:cNvPr>
          <p:cNvSpPr txBox="1"/>
          <p:nvPr/>
        </p:nvSpPr>
        <p:spPr>
          <a:xfrm>
            <a:off x="0" y="0"/>
            <a:ext cx="2413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table 1 (continued)</a:t>
            </a:r>
          </a:p>
        </p:txBody>
      </p:sp>
    </p:spTree>
    <p:extLst>
      <p:ext uri="{BB962C8B-B14F-4D97-AF65-F5344CB8AC3E}">
        <p14:creationId xmlns:p14="http://schemas.microsoft.com/office/powerpoint/2010/main" val="3821206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407</Words>
  <Application>Microsoft Macintosh PowerPoint</Application>
  <PresentationFormat>A4 Paper (210x297 mm)</PresentationFormat>
  <Paragraphs>20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7</cp:revision>
  <cp:lastPrinted>2024-02-01T12:15:18Z</cp:lastPrinted>
  <dcterms:created xsi:type="dcterms:W3CDTF">2024-02-01T12:09:59Z</dcterms:created>
  <dcterms:modified xsi:type="dcterms:W3CDTF">2024-02-01T12:16:01Z</dcterms:modified>
</cp:coreProperties>
</file>